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73" userDrawn="1">
          <p15:clr>
            <a:srgbClr val="A4A3A4"/>
          </p15:clr>
        </p15:guide>
        <p15:guide id="2" pos="547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1" autoAdjust="0"/>
    <p:restoredTop sz="94660"/>
  </p:normalViewPr>
  <p:slideViewPr>
    <p:cSldViewPr snapToGrid="0" showGuides="1">
      <p:cViewPr varScale="1">
        <p:scale>
          <a:sx n="53" d="100"/>
          <a:sy n="53" d="100"/>
        </p:scale>
        <p:origin x="90" y="1308"/>
      </p:cViewPr>
      <p:guideLst>
        <p:guide orient="horz" pos="2273"/>
        <p:guide pos="547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C09D4-E01E-416D-AC2E-153FA44372C8}" type="datetimeFigureOut">
              <a:rPr lang="de-DE" smtClean="0"/>
              <a:t>23.04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2BF37-46D9-4969-A83D-7E39398E7C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443933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C09D4-E01E-416D-AC2E-153FA44372C8}" type="datetimeFigureOut">
              <a:rPr lang="de-DE" smtClean="0"/>
              <a:t>23.04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2BF37-46D9-4969-A83D-7E39398E7C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034989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C09D4-E01E-416D-AC2E-153FA44372C8}" type="datetimeFigureOut">
              <a:rPr lang="de-DE" smtClean="0"/>
              <a:t>23.04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2BF37-46D9-4969-A83D-7E39398E7C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789775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C09D4-E01E-416D-AC2E-153FA44372C8}" type="datetimeFigureOut">
              <a:rPr lang="de-DE" smtClean="0"/>
              <a:t>23.04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2BF37-46D9-4969-A83D-7E39398E7C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458731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C09D4-E01E-416D-AC2E-153FA44372C8}" type="datetimeFigureOut">
              <a:rPr lang="de-DE" smtClean="0"/>
              <a:t>23.04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2BF37-46D9-4969-A83D-7E39398E7C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104292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C09D4-E01E-416D-AC2E-153FA44372C8}" type="datetimeFigureOut">
              <a:rPr lang="de-DE" smtClean="0"/>
              <a:t>23.04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2BF37-46D9-4969-A83D-7E39398E7C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258371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C09D4-E01E-416D-AC2E-153FA44372C8}" type="datetimeFigureOut">
              <a:rPr lang="de-DE" smtClean="0"/>
              <a:t>23.04.202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2BF37-46D9-4969-A83D-7E39398E7C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909584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C09D4-E01E-416D-AC2E-153FA44372C8}" type="datetimeFigureOut">
              <a:rPr lang="de-DE" smtClean="0"/>
              <a:t>23.04.202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2BF37-46D9-4969-A83D-7E39398E7C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898546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C09D4-E01E-416D-AC2E-153FA44372C8}" type="datetimeFigureOut">
              <a:rPr lang="de-DE" smtClean="0"/>
              <a:t>23.04.202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2BF37-46D9-4969-A83D-7E39398E7C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151201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C09D4-E01E-416D-AC2E-153FA44372C8}" type="datetimeFigureOut">
              <a:rPr lang="de-DE" smtClean="0"/>
              <a:t>23.04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2BF37-46D9-4969-A83D-7E39398E7C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844447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C09D4-E01E-416D-AC2E-153FA44372C8}" type="datetimeFigureOut">
              <a:rPr lang="de-DE" smtClean="0"/>
              <a:t>23.04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2BF37-46D9-4969-A83D-7E39398E7C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244735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2C09D4-E01E-416D-AC2E-153FA44372C8}" type="datetimeFigureOut">
              <a:rPr lang="de-DE" smtClean="0"/>
              <a:t>23.04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12BF37-46D9-4969-A83D-7E39398E7C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6104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3.emf"/><Relationship Id="rId7" Type="http://schemas.openxmlformats.org/officeDocument/2006/relationships/image" Target="../media/image5.png"/><Relationship Id="rId12" Type="http://schemas.openxmlformats.org/officeDocument/2006/relationships/image" Target="../media/image8.png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emf"/><Relationship Id="rId11" Type="http://schemas.openxmlformats.org/officeDocument/2006/relationships/image" Target="../media/image7.png"/><Relationship Id="rId5" Type="http://schemas.openxmlformats.org/officeDocument/2006/relationships/oleObject" Target="../embeddings/oleObject1.bin"/><Relationship Id="rId10" Type="http://schemas.openxmlformats.org/officeDocument/2006/relationships/image" Target="../media/image2.emf"/><Relationship Id="rId4" Type="http://schemas.openxmlformats.org/officeDocument/2006/relationships/image" Target="../media/image4.emf"/><Relationship Id="rId9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3"/>
          <a:stretch>
            <a:fillRect/>
          </a:stretch>
        </p:blipFill>
        <p:spPr>
          <a:xfrm>
            <a:off x="1097923" y="1452967"/>
            <a:ext cx="2217900" cy="2880000"/>
          </a:xfrm>
          <a:prstGeom prst="rect">
            <a:avLst/>
          </a:prstGeom>
        </p:spPr>
      </p:pic>
      <p:pic>
        <p:nvPicPr>
          <p:cNvPr id="3" name="Picture 2"/>
          <p:cNvPicPr/>
          <p:nvPr/>
        </p:nvPicPr>
        <p:blipFill>
          <a:blip r:embed="rId4"/>
          <a:stretch>
            <a:fillRect/>
          </a:stretch>
        </p:blipFill>
        <p:spPr>
          <a:xfrm>
            <a:off x="6413138" y="1452967"/>
            <a:ext cx="2217900" cy="2880000"/>
          </a:xfrm>
          <a:prstGeom prst="rect">
            <a:avLst/>
          </a:prstGeom>
        </p:spPr>
      </p:pic>
      <p:sp>
        <p:nvSpPr>
          <p:cNvPr id="4" name="TextBox 5"/>
          <p:cNvSpPr txBox="1"/>
          <p:nvPr/>
        </p:nvSpPr>
        <p:spPr>
          <a:xfrm>
            <a:off x="1097923" y="5909828"/>
            <a:ext cx="101219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sv-S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S3. </a:t>
            </a:r>
            <a:r>
              <a:rPr lang="sv-SE" sz="1050" dirty="0">
                <a:latin typeface="Arial" panose="020B0604020202020204" pitchFamily="34" charset="0"/>
                <a:cs typeface="Arial" panose="020B0604020202020204" pitchFamily="34" charset="0"/>
              </a:rPr>
              <a:t>EDI3 knockdown in SUM190PT and SKBR3 cells used for metabolite </a:t>
            </a:r>
            <a:r>
              <a:rPr lang="sv-S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analysis. EDI3 </a:t>
            </a:r>
            <a:r>
              <a:rPr lang="sv-SE" sz="1050" dirty="0">
                <a:latin typeface="Arial" panose="020B0604020202020204" pitchFamily="34" charset="0"/>
                <a:cs typeface="Arial" panose="020B0604020202020204" pitchFamily="34" charset="0"/>
              </a:rPr>
              <a:t>mRNA expression and </a:t>
            </a:r>
            <a:r>
              <a:rPr lang="sv-S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Western </a:t>
            </a:r>
            <a:r>
              <a:rPr lang="sv-SE" sz="1050" dirty="0">
                <a:latin typeface="Arial" panose="020B0604020202020204" pitchFamily="34" charset="0"/>
                <a:cs typeface="Arial" panose="020B0604020202020204" pitchFamily="34" charset="0"/>
              </a:rPr>
              <a:t>blots with corresponding quantification showing EDI3 protein expression after silencing EDI3 in (A) SUM190PT and (B) SKBR3 breast cancer cells compared with cells transfected with scrambled siRNA (siNEG #1). Replicates of these cells were used for the analysis of intracellular choline metabolites and lipids by LC-MS/MS. FM, full media control.</a:t>
            </a:r>
          </a:p>
        </p:txBody>
      </p:sp>
      <p:graphicFrame>
        <p:nvGraphicFramePr>
          <p:cNvPr id="5" name="Objek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28840238"/>
              </p:ext>
            </p:extLst>
          </p:nvPr>
        </p:nvGraphicFramePr>
        <p:xfrm>
          <a:off x="3394302" y="1408157"/>
          <a:ext cx="2106776" cy="28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6" name="Prism 10" r:id="rId5" imgW="2568848" imgH="3514383" progId="Prism10.Document">
                  <p:embed/>
                </p:oleObj>
              </mc:Choice>
              <mc:Fallback>
                <p:oleObj name="Prism 10" r:id="rId5" imgW="2568848" imgH="3514383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394302" y="1408157"/>
                        <a:ext cx="2106776" cy="28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feld 5"/>
          <p:cNvSpPr txBox="1"/>
          <p:nvPr/>
        </p:nvSpPr>
        <p:spPr>
          <a:xfrm>
            <a:off x="2705652" y="1019828"/>
            <a:ext cx="9781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M190PT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 rot="16200000">
            <a:off x="3911656" y="4620873"/>
            <a:ext cx="327919" cy="2154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FM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 rot="16200000">
            <a:off x="4100280" y="4468282"/>
            <a:ext cx="633100" cy="2154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NEG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#1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 rot="16200000">
            <a:off x="4806859" y="4465290"/>
            <a:ext cx="639084" cy="2154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siEDI3 #1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 rot="16200000">
            <a:off x="4480419" y="4465290"/>
            <a:ext cx="639084" cy="2154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siEDI3 #4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5329721" y="4928898"/>
            <a:ext cx="460183" cy="200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EDI3</a:t>
            </a:r>
          </a:p>
        </p:txBody>
      </p:sp>
      <p:sp>
        <p:nvSpPr>
          <p:cNvPr id="12" name="Textfeld 11"/>
          <p:cNvSpPr txBox="1"/>
          <p:nvPr/>
        </p:nvSpPr>
        <p:spPr>
          <a:xfrm>
            <a:off x="5329721" y="5259682"/>
            <a:ext cx="578973" cy="2154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Grafik 1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936003" y="4892543"/>
            <a:ext cx="1378800" cy="30518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Grafik 13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936003" y="5279121"/>
            <a:ext cx="1378800" cy="30555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5" name="Textfeld 14"/>
          <p:cNvSpPr txBox="1"/>
          <p:nvPr/>
        </p:nvSpPr>
        <p:spPr>
          <a:xfrm rot="16200000">
            <a:off x="9295779" y="4615790"/>
            <a:ext cx="327919" cy="2154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FM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feld 15"/>
          <p:cNvSpPr txBox="1"/>
          <p:nvPr/>
        </p:nvSpPr>
        <p:spPr>
          <a:xfrm rot="16200000">
            <a:off x="9496760" y="4463199"/>
            <a:ext cx="633100" cy="2154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NEG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#1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 rot="16200000">
            <a:off x="9822126" y="4452502"/>
            <a:ext cx="6848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siEDI3 #4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 rot="16200000">
            <a:off x="10237095" y="4452502"/>
            <a:ext cx="6848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siEDI3 #1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10750914" y="4973243"/>
            <a:ext cx="460183" cy="200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EDI3</a:t>
            </a:r>
          </a:p>
        </p:txBody>
      </p:sp>
      <p:sp>
        <p:nvSpPr>
          <p:cNvPr id="20" name="Textfeld 19"/>
          <p:cNvSpPr txBox="1"/>
          <p:nvPr/>
        </p:nvSpPr>
        <p:spPr>
          <a:xfrm>
            <a:off x="10750915" y="5316384"/>
            <a:ext cx="578973" cy="2154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1" name="Objekt 2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6638277"/>
              </p:ext>
            </p:extLst>
          </p:nvPr>
        </p:nvGraphicFramePr>
        <p:xfrm>
          <a:off x="8838819" y="1410693"/>
          <a:ext cx="2105298" cy="28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7" name="Prism 10" r:id="rId9" imgW="2568848" imgH="3514383" progId="Prism10.Document">
                  <p:embed/>
                </p:oleObj>
              </mc:Choice>
              <mc:Fallback>
                <p:oleObj name="Prism 10" r:id="rId9" imgW="2568848" imgH="3514383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8838819" y="1410693"/>
                        <a:ext cx="2105298" cy="28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2" name="Textfeld 21"/>
          <p:cNvSpPr txBox="1"/>
          <p:nvPr/>
        </p:nvSpPr>
        <p:spPr>
          <a:xfrm>
            <a:off x="8224673" y="1019828"/>
            <a:ext cx="7040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KBR3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" name="Grafik 22"/>
          <p:cNvPicPr>
            <a:picLocks noChangeAspect="1"/>
          </p:cNvPicPr>
          <p:nvPr/>
        </p:nvPicPr>
        <p:blipFill rotWithShape="1">
          <a:blip r:embed="rId11"/>
          <a:srcRect r="456"/>
          <a:stretch/>
        </p:blipFill>
        <p:spPr>
          <a:xfrm>
            <a:off x="9358813" y="4903278"/>
            <a:ext cx="1370719" cy="324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" name="Grafik 23"/>
          <p:cNvPicPr>
            <a:picLocks noChangeAspect="1"/>
          </p:cNvPicPr>
          <p:nvPr/>
        </p:nvPicPr>
        <p:blipFill rotWithShape="1">
          <a:blip r:embed="rId12"/>
          <a:srcRect l="829"/>
          <a:stretch/>
        </p:blipFill>
        <p:spPr>
          <a:xfrm>
            <a:off x="9363456" y="5274037"/>
            <a:ext cx="1367372" cy="30349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9" name="Rechteck 28"/>
          <p:cNvSpPr/>
          <p:nvPr/>
        </p:nvSpPr>
        <p:spPr>
          <a:xfrm>
            <a:off x="1792224" y="1461398"/>
            <a:ext cx="9248177" cy="41617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5" name="Textfeld 24"/>
          <p:cNvSpPr txBox="1"/>
          <p:nvPr/>
        </p:nvSpPr>
        <p:spPr>
          <a:xfrm>
            <a:off x="1952756" y="1618617"/>
            <a:ext cx="93487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EDI3 </a:t>
            </a:r>
            <a:r>
              <a:rPr lang="de-DE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endParaRPr lang="de-DE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feld 25"/>
          <p:cNvSpPr txBox="1"/>
          <p:nvPr/>
        </p:nvSpPr>
        <p:spPr>
          <a:xfrm>
            <a:off x="4156971" y="1618617"/>
            <a:ext cx="97654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EDI3 </a:t>
            </a:r>
            <a:r>
              <a:rPr lang="de-DE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endParaRPr lang="de-DE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feld 26"/>
          <p:cNvSpPr txBox="1"/>
          <p:nvPr/>
        </p:nvSpPr>
        <p:spPr>
          <a:xfrm>
            <a:off x="7315293" y="1618617"/>
            <a:ext cx="93487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EDI3 </a:t>
            </a:r>
            <a:r>
              <a:rPr lang="de-DE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endParaRPr lang="de-DE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feld 27"/>
          <p:cNvSpPr txBox="1"/>
          <p:nvPr/>
        </p:nvSpPr>
        <p:spPr>
          <a:xfrm>
            <a:off x="9617044" y="1618617"/>
            <a:ext cx="97654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EDI3 </a:t>
            </a:r>
            <a:r>
              <a:rPr lang="de-DE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endParaRPr lang="de-DE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feld 29"/>
          <p:cNvSpPr txBox="1"/>
          <p:nvPr/>
        </p:nvSpPr>
        <p:spPr>
          <a:xfrm>
            <a:off x="1089197" y="104188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feld 30"/>
          <p:cNvSpPr txBox="1"/>
          <p:nvPr/>
        </p:nvSpPr>
        <p:spPr>
          <a:xfrm>
            <a:off x="6413138" y="104188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273077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9</Words>
  <Application>Microsoft Office PowerPoint</Application>
  <PresentationFormat>Breitbild</PresentationFormat>
  <Paragraphs>21</Paragraphs>
  <Slides>1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10</vt:lpstr>
      <vt:lpstr>PowerPoint-Prä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nnika Glotzbach</dc:creator>
  <cp:lastModifiedBy>Annika Glotzbach</cp:lastModifiedBy>
  <cp:revision>17</cp:revision>
  <cp:lastPrinted>2024-04-15T10:07:15Z</cp:lastPrinted>
  <dcterms:created xsi:type="dcterms:W3CDTF">2024-04-08T10:25:41Z</dcterms:created>
  <dcterms:modified xsi:type="dcterms:W3CDTF">2024-04-23T15:22:25Z</dcterms:modified>
</cp:coreProperties>
</file>